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10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8.png" ContentType="image/png"/>
  <Override PartName="/ppt/media/image7.png" ContentType="image/png"/>
  <Override PartName="/ppt/media/image9.jpeg" ContentType="image/jpe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9.xml" ContentType="application/vnd.openxmlformats-officedocument.presentationml.slide+xml"/>
  <Override PartName="/ppt/slides/slide4.xml" ContentType="application/vnd.openxmlformats-officedocument.presentationml.slide+xml"/>
  <Override PartName="/ppt/slides/slide18.xml" ContentType="application/vnd.openxmlformats-officedocument.presentationml.slide+xml"/>
  <Override PartName="/ppt/slides/slide3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8.xml.rels" ContentType="application/vnd.openxmlformats-package.relationships+xml"/>
  <Override PartName="/ppt/slides/_rels/slide19.xml.rels" ContentType="application/vnd.openxmlformats-package.relationships+xml"/>
  <Override PartName="/ppt/slides/_rels/slide18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879BD-F148-444A-82B9-536C47532F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940CE2-FE02-4F00-82CB-318BC18C3E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0B089-9730-4094-A43B-3FEE3B82CD2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C4DD5-271E-4FBE-B5D8-A02EEDD884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BBC27-027F-4EF7-AFC2-3427C28AD1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F4777-F197-428A-9C3A-2034105A16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1FBB5F-28B1-4B49-8494-1B44143AFC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7062CA-EFEF-45A1-98B5-F49246FD99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F597E-20E3-4CFE-8A4E-6F8F3AF424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0BC5B2-5BAD-4E25-B1FA-C7292BCD85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1B8A63-6F53-490B-BA73-65488CD7B7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BB537A-7F6E-4314-AD7E-E02D0E2CC5A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383D38-E39B-4E7F-AB87-83FAC3C87DC5}" type="datetime">
              <a:rPr b="0" lang="en-CA" sz="1200" spc="-1" strike="noStrike">
                <a:solidFill>
                  <a:srgbClr val="898989"/>
                </a:solidFill>
                <a:latin typeface="Calibri"/>
              </a:rPr>
              <a:t>26-08-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C0381C-4F1F-453A-A7F6-69BE32E710C5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hyperlink" Target="http://www.abelsoft.com/" TargetMode="Externa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hyperlink" Target="http://www.abelsoft.com/" TargetMode="External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Multimedia Appendix 3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2311560" y="3886200"/>
            <a:ext cx="4520880" cy="1752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3200" spc="-1" strike="noStrike">
                <a:solidFill>
                  <a:srgbClr val="898989"/>
                </a:solidFill>
                <a:latin typeface="Calibri"/>
              </a:rPr>
              <a:t>EHR interfaces displayed on vendor websites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8263FB-5576-4838-9CC9-DF909A9FD062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Healthscreen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Content Placeholder 2"/>
          <p:cNvSpPr/>
          <p:nvPr/>
        </p:nvSpPr>
        <p:spPr>
          <a:xfrm>
            <a:off x="2268360" y="2781360"/>
            <a:ext cx="4607280" cy="12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HS Practice (primary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19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AF3E0A-0921-4B2A-A098-72349C584E14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EB1D76-D636-447F-8BE1-2786B9D48CD1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Jonok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JonokeMed (primary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http://www.jonoke.com; taken on August 19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270EB64-A433-439F-A956-76791C81608D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Picture 9" descr="jonoke_med_encounter.JPG"/>
          <p:cNvPicPr/>
          <p:nvPr/>
        </p:nvPicPr>
        <p:blipFill>
          <a:blip r:embed="rId1"/>
          <a:srcRect l="27984" t="26861" r="22475" b="20427"/>
          <a:stretch/>
        </p:blipFill>
        <p:spPr>
          <a:xfrm>
            <a:off x="2627280" y="1916280"/>
            <a:ext cx="3889440" cy="295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303F130-9828-4925-803D-0C435E81DACD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Nightingal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Content Placeholder 2"/>
          <p:cNvSpPr/>
          <p:nvPr/>
        </p:nvSpPr>
        <p:spPr>
          <a:xfrm>
            <a:off x="2158920" y="2781360"/>
            <a:ext cx="4826160" cy="129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Nightingale On Demand (primary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25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DC926A-CEC8-4EEA-9B4D-A3896ABF5703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52ECF2-1E59-4626-941E-CD677F1797FA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Optimed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Accuro (primary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http://www.optimedsoftware.com/index.php; taken on August 26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A11563-D498-4A8C-82A4-47DD6430BC11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9" descr="optimed_screen3.jpg"/>
          <p:cNvPicPr/>
          <p:nvPr/>
        </p:nvPicPr>
        <p:blipFill>
          <a:blip r:embed="rId1"/>
          <a:stretch/>
        </p:blipFill>
        <p:spPr>
          <a:xfrm>
            <a:off x="973080" y="990720"/>
            <a:ext cx="7197840" cy="4741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46D18D-98DE-43DA-8B08-A55353143F2E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OSCAR (McMaster University)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OSCAR (primary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http://oscarcanada.org; taken on August 21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6F253B4-60FC-4EED-83EE-EC8B9831BB24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5" name="Picture 9" descr="oscar_fromtour.PNG"/>
          <p:cNvPicPr/>
          <p:nvPr/>
        </p:nvPicPr>
        <p:blipFill>
          <a:blip r:embed="rId1"/>
          <a:stretch/>
        </p:blipFill>
        <p:spPr>
          <a:xfrm>
            <a:off x="990720" y="912960"/>
            <a:ext cx="7162560" cy="4848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E3DF5D-963A-4A5F-907B-E19E29B0E851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P &amp; P Data System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Clinic Information System (primary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http://www.p-pdata.com; taken on August 28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192321-8E9C-4C78-8FBC-F2A4CA339FA8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1" name="Picture 9" descr="ppdata_frombrochure.PNG"/>
          <p:cNvPicPr/>
          <p:nvPr/>
        </p:nvPicPr>
        <p:blipFill>
          <a:blip r:embed="rId1"/>
          <a:stretch/>
        </p:blipFill>
        <p:spPr>
          <a:xfrm>
            <a:off x="2257560" y="1967040"/>
            <a:ext cx="4628880" cy="2923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FB9EAB-ED59-4921-B073-F73538418FB5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Practice Solution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300" spc="-1" strike="noStrike">
                <a:solidFill>
                  <a:srgbClr val="000000"/>
                </a:solidFill>
                <a:latin typeface="Calibri"/>
              </a:rPr>
              <a:t>EHR: PS Suite (primary care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2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300" spc="-1" strike="noStrike">
                <a:solidFill>
                  <a:srgbClr val="000000"/>
                </a:solidFill>
                <a:latin typeface="Calibri"/>
              </a:rPr>
              <a:t>Vendor URL: http://www.practicesolutions.ca/index.cfm/ci_id/47452/la_id/1.htm; taken on August 25, 2010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Footer Placeholder 3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0338E5-472E-4AC2-A831-05A6E8EDEF6A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9" descr="pracsolns_emrshot1.jpg"/>
          <p:cNvPicPr/>
          <p:nvPr/>
        </p:nvPicPr>
        <p:blipFill>
          <a:blip r:embed="rId1"/>
          <a:stretch/>
        </p:blipFill>
        <p:spPr>
          <a:xfrm>
            <a:off x="546120" y="901800"/>
            <a:ext cx="8051760" cy="4830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E84BBE-E9B3-4348-9829-2EE93076170E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QuadraMed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Content Placeholder 2"/>
          <p:cNvSpPr/>
          <p:nvPr/>
        </p:nvSpPr>
        <p:spPr>
          <a:xfrm>
            <a:off x="2268360" y="2889360"/>
            <a:ext cx="4607280" cy="10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QCPR (acute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29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136FEC-F2A1-4576-BF92-2AC2F750CAF5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566EC3-89AC-494D-B19C-7410BA79102A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Telus Health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oacis (acute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http://www.telushealth.com/en/default.aspx; taken on August 29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0AE504-44BE-4673-A0EE-8BDA4CCD72C7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8" name="Picture 9" descr="oacis_fromClinicalViewerBroch.PNG"/>
          <p:cNvPicPr/>
          <p:nvPr/>
        </p:nvPicPr>
        <p:blipFill>
          <a:blip r:embed="rId1"/>
          <a:stretch/>
        </p:blipFill>
        <p:spPr>
          <a:xfrm>
            <a:off x="2143080" y="1595520"/>
            <a:ext cx="4857840" cy="3666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BA5A9D-BC2D-447D-85DF-4FECCC24C984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York-Med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Content Placeholder 2"/>
          <p:cNvSpPr/>
          <p:nvPr/>
        </p:nvSpPr>
        <p:spPr>
          <a:xfrm>
            <a:off x="2268360" y="2924280"/>
            <a:ext cx="4607280" cy="1009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York-Med MD Suite (primary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30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A5B554-CF5C-40A1-B2B8-FE08200F32A0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ABELSof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"/>
          <p:cNvSpPr txBox="1"/>
          <p:nvPr/>
        </p:nvSpPr>
        <p:spPr>
          <a:xfrm>
            <a:off x="2232000" y="2889360"/>
            <a:ext cx="4680000" cy="10792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ABELMed (primary care)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14, 2010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 algn="ctr">
              <a:lnSpc>
                <a:spcPct val="8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Footer Placeholder 3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531D98-DF96-43E9-98F4-851C41FDD12E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Footer Placeholder 3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E517B5-643D-471B-A4F4-ADCF657D6186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AlphaI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s: GlobeMed (primary care), UHM (primary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</a:t>
            </a:r>
            <a:r>
              <a:rPr b="0" lang="en-CA" sz="1500" spc="-1" strike="noStrike" u="sng">
                <a:solidFill>
                  <a:srgbClr val="0000ff"/>
                </a:solidFill>
                <a:uFillTx/>
                <a:latin typeface="Calibri"/>
                <a:hlinkClick r:id="rId1"/>
              </a:rPr>
              <a:t>http://www.alpha-it.com</a:t>
            </a: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; taken on August 16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B2F4EC-FF41-4CCC-9FF5-36C85791CC7B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9" descr="alphaIT_sketch.JPG"/>
          <p:cNvPicPr/>
          <p:nvPr/>
        </p:nvPicPr>
        <p:blipFill>
          <a:blip r:embed="rId2"/>
          <a:stretch/>
        </p:blipFill>
        <p:spPr>
          <a:xfrm>
            <a:off x="1187280" y="981000"/>
            <a:ext cx="6946920" cy="4751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Footer Placeholder 3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55B9A1E-4B4E-4A9B-8CCA-CD70CAB11181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B Sharp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"/>
          <p:cNvSpPr txBox="1"/>
          <p:nvPr/>
        </p:nvSpPr>
        <p:spPr>
          <a:xfrm>
            <a:off x="755640" y="5805000"/>
            <a:ext cx="7570800" cy="5367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B Care (acute care)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</a:t>
            </a:r>
            <a:r>
              <a:rPr b="0" lang="en-CA" sz="1500" spc="-1" strike="noStrike" u="sng">
                <a:solidFill>
                  <a:srgbClr val="0000ff"/>
                </a:solidFill>
                <a:uFillTx/>
                <a:latin typeface="Calibri"/>
                <a:hlinkClick r:id="rId1"/>
              </a:rPr>
              <a:t>http://www.bsharp.com</a:t>
            </a: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; taken on August 16, 2010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822DB0-0F77-4775-9C39-295A8A02E46F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9" descr="bsharp_bcare.JPG"/>
          <p:cNvPicPr/>
          <p:nvPr/>
        </p:nvPicPr>
        <p:blipFill>
          <a:blip r:embed="rId2"/>
          <a:stretch/>
        </p:blipFill>
        <p:spPr>
          <a:xfrm>
            <a:off x="2590920" y="2076480"/>
            <a:ext cx="3962160" cy="2705040"/>
          </a:xfrm>
          <a:prstGeom prst="rect">
            <a:avLst/>
          </a:prstGeom>
          <a:ln w="0">
            <a:noFill/>
          </a:ln>
        </p:spPr>
      </p:pic>
      <p:sp>
        <p:nvSpPr>
          <p:cNvPr id="59" name="TextBox 10"/>
          <p:cNvSpPr/>
          <p:nvPr/>
        </p:nvSpPr>
        <p:spPr>
          <a:xfrm>
            <a:off x="1332000" y="5157720"/>
            <a:ext cx="648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1800" spc="-1" strike="noStrike">
                <a:solidFill>
                  <a:srgbClr val="000000"/>
                </a:solidFill>
                <a:latin typeface="Calibri"/>
              </a:rPr>
              <a:t>Note: Unclear whether this is the actual interface, or a stock imag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B0DC4C-0250-4E01-A09D-AF21F5B78CFB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Cerner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PowerChart EMR (acute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Vendor URL: http://www.cerner.com/public/default.asp?id=18731; taken on August 16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0F44F0-D4BE-4121-B7B2-720AC55389AB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9" descr="cerner_gui.gif"/>
          <p:cNvPicPr/>
          <p:nvPr/>
        </p:nvPicPr>
        <p:blipFill>
          <a:blip r:embed="rId1"/>
          <a:stretch/>
        </p:blipFill>
        <p:spPr>
          <a:xfrm>
            <a:off x="3571920" y="2762280"/>
            <a:ext cx="2000160" cy="1333440"/>
          </a:xfrm>
          <a:prstGeom prst="rect">
            <a:avLst/>
          </a:prstGeom>
          <a:ln w="0">
            <a:noFill/>
          </a:ln>
        </p:spPr>
      </p:pic>
      <p:sp>
        <p:nvSpPr>
          <p:cNvPr id="66" name="TextBox 10"/>
          <p:cNvSpPr/>
          <p:nvPr/>
        </p:nvSpPr>
        <p:spPr>
          <a:xfrm>
            <a:off x="1332000" y="4724280"/>
            <a:ext cx="648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CA" sz="1800" spc="-1" strike="noStrike">
                <a:solidFill>
                  <a:srgbClr val="000000"/>
                </a:solidFill>
                <a:latin typeface="Calibri"/>
              </a:rPr>
              <a:t>Note: Unclear whether this is the actual interface, or a stock image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49751AB-98D9-4268-A83A-D567AE09788D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Clinicar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ontent Placeholder 2"/>
          <p:cNvSpPr/>
          <p:nvPr/>
        </p:nvSpPr>
        <p:spPr>
          <a:xfrm>
            <a:off x="755640" y="5805360"/>
            <a:ext cx="7570800" cy="53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EHR: EliteCare (primary care)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80000"/>
              </a:lnSpc>
              <a:spcBef>
                <a:spcPts val="37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500" spc="-1" strike="noStrike">
                <a:solidFill>
                  <a:srgbClr val="000000"/>
                </a:solidFill>
                <a:latin typeface="Calibri"/>
              </a:rPr>
              <a:t>Source URL: http://www.clinicare.com; taken on August 17, 20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187FD7-A731-4CE9-A460-1048C5084880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8" descr="clinicare_cmrxp4.jpg"/>
          <p:cNvPicPr/>
          <p:nvPr/>
        </p:nvPicPr>
        <p:blipFill>
          <a:blip r:embed="rId1"/>
          <a:stretch/>
        </p:blipFill>
        <p:spPr>
          <a:xfrm>
            <a:off x="1531800" y="914400"/>
            <a:ext cx="6080400" cy="4863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662089-6A2A-4FF4-911F-0C522A8E080B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Eclipsy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ontent Placeholder 2"/>
          <p:cNvSpPr/>
          <p:nvPr/>
        </p:nvSpPr>
        <p:spPr>
          <a:xfrm>
            <a:off x="1781280" y="2637000"/>
            <a:ext cx="5581440" cy="158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s: Sunrise Ambulatory Care (primary care), Sunrise Clinical Manager (acute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17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B95683-83B9-4413-AEC7-ACA7D32D9494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BEBFA3-14A9-470B-8AE3-84936AE1DB2A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EMI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ontent Placeholder 2"/>
          <p:cNvSpPr/>
          <p:nvPr/>
        </p:nvSpPr>
        <p:spPr>
          <a:xfrm>
            <a:off x="2063880" y="2708280"/>
            <a:ext cx="5016240" cy="144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EMIS (primary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18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73C1D78-7964-47A1-8CCE-1059134F2C45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Footer Placeholder 1"/>
          <p:cNvSpPr/>
          <p:nvPr/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200" spc="-1" strike="noStrike">
                <a:solidFill>
                  <a:srgbClr val="898989"/>
                </a:solidFill>
                <a:latin typeface="Calibri"/>
              </a:rPr>
              <a:t>Multimedia Appendix 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lide Number Placeholder 2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B5303D-EC7F-44AD-A2B1-6AC1DC6BBF7F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itle 1"/>
          <p:cNvSpPr/>
          <p:nvPr/>
        </p:nvSpPr>
        <p:spPr>
          <a:xfrm>
            <a:off x="468360" y="189000"/>
            <a:ext cx="8229600" cy="86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4400" spc="-1" strike="noStrike">
                <a:solidFill>
                  <a:srgbClr val="000000"/>
                </a:solidFill>
                <a:latin typeface="Calibri"/>
              </a:rPr>
              <a:t>GE Healthcar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Content Placeholder 2"/>
          <p:cNvSpPr/>
          <p:nvPr/>
        </p:nvSpPr>
        <p:spPr>
          <a:xfrm>
            <a:off x="2268360" y="2744640"/>
            <a:ext cx="4607280" cy="136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EHR: Centricity (primary care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 algn="ctr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2000" spc="-1" strike="noStrike">
                <a:solidFill>
                  <a:srgbClr val="000000"/>
                </a:solidFill>
                <a:latin typeface="Calibri"/>
              </a:rPr>
              <a:t>No images available as of August 18, 20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Slide Number Placeholder 4"/>
          <p:cNvSpPr/>
          <p:nvPr/>
        </p:nvSpPr>
        <p:spPr>
          <a:xfrm>
            <a:off x="655308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F2C69F-31F5-40EA-8462-1FAA010B2475}" type="slidenum">
              <a:rPr b="0" lang="en-CA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5T02:42:42Z</dcterms:created>
  <dc:creator>nat</dc:creator>
  <dc:description/>
  <dc:language>en-US</dc:language>
  <cp:lastModifiedBy>Aviv Shachak</cp:lastModifiedBy>
  <dcterms:modified xsi:type="dcterms:W3CDTF">2013-02-19T13:49:39Z</dcterms:modified>
  <cp:revision>39</cp:revision>
  <dc:subject/>
  <dc:title>Multimedia Appendix A</dc:title>
</cp:coreProperties>
</file>